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0" r:id="rId5"/>
    <p:sldId id="261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32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271163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85829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81379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91082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96538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78167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59473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78354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90073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59604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994137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71886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6E1D4ED-ACB6-BA27-325D-604E34BB4DAA}"/>
              </a:ext>
            </a:extLst>
          </p:cNvPr>
          <p:cNvSpPr txBox="1"/>
          <p:nvPr/>
        </p:nvSpPr>
        <p:spPr>
          <a:xfrm>
            <a:off x="1404523" y="3060712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peats of data presented in Figure 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3663958-984A-6A84-6030-B4B2A79F83FB}"/>
              </a:ext>
            </a:extLst>
          </p:cNvPr>
          <p:cNvSpPr txBox="1"/>
          <p:nvPr/>
        </p:nvSpPr>
        <p:spPr>
          <a:xfrm>
            <a:off x="853701" y="5078281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C57BL/6 – 1h timepoint individual repeats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D29164F5-0A78-AF74-31D9-9634F5B390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930" y="5572894"/>
            <a:ext cx="1991095" cy="3608859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192864E-07D5-EB08-AF30-6F5B275AFCF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070" y="5572894"/>
            <a:ext cx="1991095" cy="3608859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656CCA58-55C6-538E-96E8-5C1CD3E3896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0210" y="5572894"/>
            <a:ext cx="1991095" cy="360885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A3B3813-B831-9120-578A-4E8A70557D70}"/>
              </a:ext>
            </a:extLst>
          </p:cNvPr>
          <p:cNvSpPr txBox="1"/>
          <p:nvPr/>
        </p:nvSpPr>
        <p:spPr>
          <a:xfrm>
            <a:off x="710010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B5209B5-F11D-C1C3-2D75-96BFAAE7798D}"/>
              </a:ext>
            </a:extLst>
          </p:cNvPr>
          <p:cNvSpPr txBox="1"/>
          <p:nvPr/>
        </p:nvSpPr>
        <p:spPr>
          <a:xfrm>
            <a:off x="2859453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13F7C16-CB67-C014-5F87-DBDE962DD3A9}"/>
              </a:ext>
            </a:extLst>
          </p:cNvPr>
          <p:cNvSpPr txBox="1"/>
          <p:nvPr/>
        </p:nvSpPr>
        <p:spPr>
          <a:xfrm>
            <a:off x="5083724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359104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63663958-984A-6A84-6030-B4B2A79F83FB}"/>
              </a:ext>
            </a:extLst>
          </p:cNvPr>
          <p:cNvSpPr txBox="1"/>
          <p:nvPr/>
        </p:nvSpPr>
        <p:spPr>
          <a:xfrm>
            <a:off x="506627" y="5090291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– 1h timepoint individual repeat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A3D4414-7C5F-EEF7-31D6-042162E5C853}"/>
              </a:ext>
            </a:extLst>
          </p:cNvPr>
          <p:cNvSpPr txBox="1"/>
          <p:nvPr/>
        </p:nvSpPr>
        <p:spPr>
          <a:xfrm>
            <a:off x="506627" y="544617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– 1h timepoint individual repeats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A283B8B1-06D8-8BBC-9A85-CF8307CDFC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241" y="1046209"/>
            <a:ext cx="1991095" cy="360886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3D8D53F-A98C-194F-2921-CE99EC221AF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3453" y="1046206"/>
            <a:ext cx="1991095" cy="360886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88324EBD-EEE7-F76E-DBF8-C1A56930A5E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5665" y="1046207"/>
            <a:ext cx="1991095" cy="360885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FC809ED0-A141-E11F-70A5-FC8C01F79EC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717" y="5525520"/>
            <a:ext cx="1980619" cy="358987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C6C9FABC-050A-D0B8-02E8-C3ECF67B6BC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3927" y="5525520"/>
            <a:ext cx="1980620" cy="3589873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BD2F9059-9EDA-694E-8024-BDEAEFCE1A2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6139" y="5525518"/>
            <a:ext cx="1980620" cy="358987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7979C8E-4597-A125-DABD-F63C8BC40C54}"/>
              </a:ext>
            </a:extLst>
          </p:cNvPr>
          <p:cNvSpPr txBox="1"/>
          <p:nvPr/>
        </p:nvSpPr>
        <p:spPr>
          <a:xfrm>
            <a:off x="710010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3FD469D-D3BC-386A-F744-A4039362F0A1}"/>
              </a:ext>
            </a:extLst>
          </p:cNvPr>
          <p:cNvSpPr txBox="1"/>
          <p:nvPr/>
        </p:nvSpPr>
        <p:spPr>
          <a:xfrm>
            <a:off x="2859453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A43E95D-EBCA-E1AD-08AB-D78EE5A423F1}"/>
              </a:ext>
            </a:extLst>
          </p:cNvPr>
          <p:cNvSpPr txBox="1"/>
          <p:nvPr/>
        </p:nvSpPr>
        <p:spPr>
          <a:xfrm>
            <a:off x="5083724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301FE1-3384-16DB-DEC8-C0653729A82D}"/>
              </a:ext>
            </a:extLst>
          </p:cNvPr>
          <p:cNvSpPr txBox="1"/>
          <p:nvPr/>
        </p:nvSpPr>
        <p:spPr>
          <a:xfrm>
            <a:off x="735029" y="4655066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02328AB-1921-A937-4D8D-57308E6DD34A}"/>
              </a:ext>
            </a:extLst>
          </p:cNvPr>
          <p:cNvSpPr txBox="1"/>
          <p:nvPr/>
        </p:nvSpPr>
        <p:spPr>
          <a:xfrm>
            <a:off x="2884472" y="4655066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24C97D9-E4A7-7925-8497-7376BECEAE90}"/>
              </a:ext>
            </a:extLst>
          </p:cNvPr>
          <p:cNvSpPr txBox="1"/>
          <p:nvPr/>
        </p:nvSpPr>
        <p:spPr>
          <a:xfrm>
            <a:off x="5108743" y="4655066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40305628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63663958-984A-6A84-6030-B4B2A79F83FB}"/>
              </a:ext>
            </a:extLst>
          </p:cNvPr>
          <p:cNvSpPr txBox="1"/>
          <p:nvPr/>
        </p:nvSpPr>
        <p:spPr>
          <a:xfrm>
            <a:off x="506627" y="5108598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C57BL/6 – 48h timepoint individual repeat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A3D4414-7C5F-EEF7-31D6-042162E5C853}"/>
              </a:ext>
            </a:extLst>
          </p:cNvPr>
          <p:cNvSpPr txBox="1"/>
          <p:nvPr/>
        </p:nvSpPr>
        <p:spPr>
          <a:xfrm>
            <a:off x="505314" y="586951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 – 1h timepoint individual repeat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8DFD6EA-3A01-2417-FA34-162B7BE1E7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717" y="1046207"/>
            <a:ext cx="1991095" cy="360885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C6FA94F-A333-2858-77A7-289B9EE9A4B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3928" y="1046206"/>
            <a:ext cx="1991095" cy="360885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DE49A8D-28D2-0D20-0047-D890674D0E4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6138" y="1046205"/>
            <a:ext cx="1980620" cy="358987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B0976A2-6F94-BACC-CB78-7BFBFE49993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550" y="5544509"/>
            <a:ext cx="1980620" cy="358987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811377F8-1063-1AB3-59A0-B03F99FE072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690" y="5544509"/>
            <a:ext cx="1996332" cy="361835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EC3822E-B504-6AC7-98B8-59A809A200B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6139" y="5543822"/>
            <a:ext cx="1980621" cy="358987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ECB5B44-E173-C477-D1BF-5463B1121B4D}"/>
              </a:ext>
            </a:extLst>
          </p:cNvPr>
          <p:cNvSpPr txBox="1"/>
          <p:nvPr/>
        </p:nvSpPr>
        <p:spPr>
          <a:xfrm>
            <a:off x="710010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3446821-DA02-FD66-443B-3CD706A9D291}"/>
              </a:ext>
            </a:extLst>
          </p:cNvPr>
          <p:cNvSpPr txBox="1"/>
          <p:nvPr/>
        </p:nvSpPr>
        <p:spPr>
          <a:xfrm>
            <a:off x="2859453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375B2A8-B92B-D96F-366C-3F16D39B06C1}"/>
              </a:ext>
            </a:extLst>
          </p:cNvPr>
          <p:cNvSpPr txBox="1"/>
          <p:nvPr/>
        </p:nvSpPr>
        <p:spPr>
          <a:xfrm>
            <a:off x="5083724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7535FD6-1B3B-D108-5DC4-1FAF7096B361}"/>
              </a:ext>
            </a:extLst>
          </p:cNvPr>
          <p:cNvSpPr txBox="1"/>
          <p:nvPr/>
        </p:nvSpPr>
        <p:spPr>
          <a:xfrm>
            <a:off x="766435" y="4701971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C57823C-E139-4A4C-3D96-0C5F58DD27C2}"/>
              </a:ext>
            </a:extLst>
          </p:cNvPr>
          <p:cNvSpPr txBox="1"/>
          <p:nvPr/>
        </p:nvSpPr>
        <p:spPr>
          <a:xfrm>
            <a:off x="2915878" y="4701971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C558BDD-BA5F-EC6D-206B-B909A09ACE04}"/>
              </a:ext>
            </a:extLst>
          </p:cNvPr>
          <p:cNvSpPr txBox="1"/>
          <p:nvPr/>
        </p:nvSpPr>
        <p:spPr>
          <a:xfrm>
            <a:off x="5140149" y="4701971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23997120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63663958-984A-6A84-6030-B4B2A79F83FB}"/>
              </a:ext>
            </a:extLst>
          </p:cNvPr>
          <p:cNvSpPr txBox="1"/>
          <p:nvPr/>
        </p:nvSpPr>
        <p:spPr>
          <a:xfrm>
            <a:off x="710010" y="5011519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– 48h timepoint individual repeat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2BC4AAE-A42B-36F7-7218-FA23961FB4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550" y="971822"/>
            <a:ext cx="2083234" cy="377586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B2B3DB7-27BB-4FF0-FAE7-B68557ADDFB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690" y="971822"/>
            <a:ext cx="2083234" cy="377586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C464BD06-D02F-A4C4-05C2-349C157558C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6138" y="971822"/>
            <a:ext cx="2083234" cy="377586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1B4E038-178C-F2F9-5CA0-B8AD22F65C7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564" y="5372360"/>
            <a:ext cx="2075220" cy="3761336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7FA54DDD-0097-C031-8C36-ECA92E1B922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691" y="5432906"/>
            <a:ext cx="2041815" cy="370079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6943438-D757-5204-A38F-2D4E50E595F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6138" y="5372360"/>
            <a:ext cx="2075220" cy="376133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ED2E664-5798-F5F2-E3C2-5AB939DE2910}"/>
              </a:ext>
            </a:extLst>
          </p:cNvPr>
          <p:cNvSpPr txBox="1"/>
          <p:nvPr/>
        </p:nvSpPr>
        <p:spPr>
          <a:xfrm>
            <a:off x="710010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805BC6D-190D-1698-F28E-18E12D3255F7}"/>
              </a:ext>
            </a:extLst>
          </p:cNvPr>
          <p:cNvSpPr txBox="1"/>
          <p:nvPr/>
        </p:nvSpPr>
        <p:spPr>
          <a:xfrm>
            <a:off x="2859453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C927A25-5BE9-7233-06F1-1F242C80B747}"/>
              </a:ext>
            </a:extLst>
          </p:cNvPr>
          <p:cNvSpPr txBox="1"/>
          <p:nvPr/>
        </p:nvSpPr>
        <p:spPr>
          <a:xfrm>
            <a:off x="5083724" y="943231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B511E5B-4AF7-E184-99C5-E610F3718AFB}"/>
              </a:ext>
            </a:extLst>
          </p:cNvPr>
          <p:cNvSpPr txBox="1"/>
          <p:nvPr/>
        </p:nvSpPr>
        <p:spPr>
          <a:xfrm>
            <a:off x="583898" y="473919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91023E2-3721-A153-C49A-B26829FBC411}"/>
              </a:ext>
            </a:extLst>
          </p:cNvPr>
          <p:cNvSpPr txBox="1"/>
          <p:nvPr/>
        </p:nvSpPr>
        <p:spPr>
          <a:xfrm>
            <a:off x="2733341" y="473919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7B6E58-76F8-E09F-B1B3-9D4ECD8D896F}"/>
              </a:ext>
            </a:extLst>
          </p:cNvPr>
          <p:cNvSpPr txBox="1"/>
          <p:nvPr/>
        </p:nvSpPr>
        <p:spPr>
          <a:xfrm>
            <a:off x="4957612" y="473919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47665DA-842A-1E9E-171E-5EE618152143}"/>
              </a:ext>
            </a:extLst>
          </p:cNvPr>
          <p:cNvSpPr txBox="1"/>
          <p:nvPr/>
        </p:nvSpPr>
        <p:spPr>
          <a:xfrm>
            <a:off x="710009" y="576463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 – 48h timepoint individual repeats</a:t>
            </a:r>
          </a:p>
        </p:txBody>
      </p:sp>
    </p:spTree>
    <p:extLst>
      <p:ext uri="{BB962C8B-B14F-4D97-AF65-F5344CB8AC3E}">
        <p14:creationId xmlns:p14="http://schemas.microsoft.com/office/powerpoint/2010/main" val="35201602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A3D4414-7C5F-EEF7-31D6-042162E5C853}"/>
              </a:ext>
            </a:extLst>
          </p:cNvPr>
          <p:cNvSpPr txBox="1"/>
          <p:nvPr/>
        </p:nvSpPr>
        <p:spPr>
          <a:xfrm>
            <a:off x="506627" y="496396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 – 48h timepoint individual repeat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A508340-A519-5FEC-705C-5F4AA033A4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565" y="953594"/>
            <a:ext cx="2077037" cy="376462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A62A79B-DB16-F5D3-4BFA-2F4B3D024A8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9597" y="953594"/>
            <a:ext cx="2077037" cy="376462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F679BB6-760F-16D0-BD0C-FBDD2B3F367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0278" y="986346"/>
            <a:ext cx="2075221" cy="376133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6A94E7D-5E32-6FF9-4CA0-5F3AF7664DE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781" y="6686395"/>
            <a:ext cx="1659175" cy="301573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01B8443-1F8C-4018-F529-89196728BA0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4783" y="6686395"/>
            <a:ext cx="1659176" cy="301573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6EF4C7C-AAB8-2A9C-7CD8-5B56AFB881F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1788" y="6686396"/>
            <a:ext cx="1659175" cy="301573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810157" y="6229197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N.B. ROI calculation – example of ROI inpaintin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E631E8F-278B-5CCD-7A80-72C70CCDA0DA}"/>
              </a:ext>
            </a:extLst>
          </p:cNvPr>
          <p:cNvSpPr txBox="1"/>
          <p:nvPr/>
        </p:nvSpPr>
        <p:spPr>
          <a:xfrm>
            <a:off x="810158" y="4835549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8909FC9-7185-4159-B58E-EF7496C3DDEC}"/>
              </a:ext>
            </a:extLst>
          </p:cNvPr>
          <p:cNvSpPr txBox="1"/>
          <p:nvPr/>
        </p:nvSpPr>
        <p:spPr>
          <a:xfrm>
            <a:off x="2959601" y="4835549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BA545F9-0CE2-C8C9-E655-44FA4D8E6AC6}"/>
              </a:ext>
            </a:extLst>
          </p:cNvPr>
          <p:cNvSpPr txBox="1"/>
          <p:nvPr/>
        </p:nvSpPr>
        <p:spPr>
          <a:xfrm>
            <a:off x="5183872" y="4835549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4258033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46</Words>
  <Application>Microsoft Office PowerPoint</Application>
  <PresentationFormat>A4 Paper (210x297 mm)</PresentationFormat>
  <Paragraphs>3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homas Balligand</dc:creator>
  <cp:lastModifiedBy>Thomas Balligand</cp:lastModifiedBy>
  <cp:revision>1</cp:revision>
  <dcterms:created xsi:type="dcterms:W3CDTF">2025-07-24T09:24:58Z</dcterms:created>
  <dcterms:modified xsi:type="dcterms:W3CDTF">2025-07-24T09:28:41Z</dcterms:modified>
</cp:coreProperties>
</file>